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30" d="100"/>
          <a:sy n="130" d="100"/>
        </p:scale>
        <p:origin x="-1320" y="-126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组合 37"/>
          <p:cNvGrpSpPr/>
          <p:nvPr/>
        </p:nvGrpSpPr>
        <p:grpSpPr>
          <a:xfrm>
            <a:off x="1845816" y="404664"/>
            <a:ext cx="5452367" cy="5616624"/>
            <a:chOff x="1327520" y="908720"/>
            <a:chExt cx="5452367" cy="5616624"/>
          </a:xfrm>
          <a:noFill/>
        </p:grpSpPr>
        <p:sp>
          <p:nvSpPr>
            <p:cNvPr id="4" name="矩形 3"/>
            <p:cNvSpPr/>
            <p:nvPr/>
          </p:nvSpPr>
          <p:spPr>
            <a:xfrm>
              <a:off x="3513643" y="908720"/>
              <a:ext cx="1080120" cy="288032"/>
            </a:xfrm>
            <a:prstGeom prst="rect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aw data</a:t>
              </a:r>
              <a:endParaRPr lang="zh-CN" alt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矩形 4"/>
            <p:cNvSpPr/>
            <p:nvPr/>
          </p:nvSpPr>
          <p:spPr>
            <a:xfrm>
              <a:off x="3441636" y="1877554"/>
              <a:ext cx="1224135" cy="288032"/>
            </a:xfrm>
            <a:prstGeom prst="rect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l variants</a:t>
              </a:r>
              <a:endParaRPr lang="zh-CN" alt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矩形 5"/>
            <p:cNvSpPr/>
            <p:nvPr/>
          </p:nvSpPr>
          <p:spPr>
            <a:xfrm>
              <a:off x="2334658" y="2846388"/>
              <a:ext cx="3438091" cy="288032"/>
            </a:xfrm>
            <a:prstGeom prst="rect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move </a:t>
              </a:r>
              <a:r>
                <a:rPr lang="en-US" altLang="zh-CN" sz="16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xAc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6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af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&gt;0.001 variants</a:t>
              </a:r>
              <a:endParaRPr lang="zh-CN" alt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矩形 6"/>
            <p:cNvSpPr/>
            <p:nvPr/>
          </p:nvSpPr>
          <p:spPr>
            <a:xfrm>
              <a:off x="3045591" y="1393137"/>
              <a:ext cx="2016224" cy="288032"/>
            </a:xfrm>
            <a:prstGeom prst="rect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on 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porter 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.2</a:t>
              </a:r>
              <a:endParaRPr lang="zh-CN" alt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>
              <a:off x="2191506" y="3815222"/>
              <a:ext cx="3724394" cy="288032"/>
            </a:xfrm>
            <a:prstGeom prst="rect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move </a:t>
              </a:r>
              <a:r>
                <a:rPr lang="en-US" altLang="zh-CN" sz="16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tronic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ynonymous 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s</a:t>
              </a:r>
              <a:endParaRPr lang="zh-CN" alt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>
              <a:off x="2334658" y="2361971"/>
              <a:ext cx="3438091" cy="288032"/>
            </a:xfrm>
            <a:prstGeom prst="rect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move </a:t>
              </a:r>
              <a:r>
                <a:rPr lang="en-US" altLang="zh-CN" sz="16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linVar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benign variants </a:t>
              </a:r>
              <a:endParaRPr lang="zh-CN" alt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>
              <a:off x="1678790" y="3330805"/>
              <a:ext cx="4749826" cy="288032"/>
            </a:xfrm>
            <a:prstGeom prst="rect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move local healthy 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xome database 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s</a:t>
              </a:r>
              <a:endParaRPr lang="zh-CN" alt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>
              <a:off x="2102791" y="4299639"/>
              <a:ext cx="3901825" cy="288032"/>
            </a:xfrm>
            <a:prstGeom prst="rect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move 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FT/</a:t>
              </a:r>
              <a:r>
                <a:rPr lang="en-US" altLang="zh-CN" sz="16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olyPhen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enign variants</a:t>
              </a:r>
              <a:endParaRPr lang="zh-CN" alt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>
              <a:off x="2568474" y="4784056"/>
              <a:ext cx="2970459" cy="288032"/>
            </a:xfrm>
            <a:prstGeom prst="rect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move </a:t>
              </a:r>
              <a:r>
                <a:rPr lang="en-US" altLang="zh-CN" sz="16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hyloP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&lt;0 variants</a:t>
              </a:r>
              <a:endParaRPr lang="zh-CN" alt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>
              <a:off x="1327520" y="5268473"/>
              <a:ext cx="5452367" cy="288032"/>
            </a:xfrm>
            <a:prstGeom prst="rect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move 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ypertension/</a:t>
              </a:r>
              <a:r>
                <a:rPr lang="en-US" altLang="zh-CN" sz="16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rachydactyly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unrelated </a:t>
              </a:r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s</a:t>
              </a:r>
              <a:endParaRPr lang="zh-CN" alt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>
              <a:off x="2578025" y="5752890"/>
              <a:ext cx="2951356" cy="288032"/>
            </a:xfrm>
            <a:prstGeom prst="rect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anger sequencing validation</a:t>
              </a:r>
              <a:endParaRPr lang="zh-CN" alt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>
              <a:off x="2578025" y="6237312"/>
              <a:ext cx="2951356" cy="288032"/>
            </a:xfrm>
            <a:prstGeom prst="rect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otential pathogenic variant</a:t>
              </a:r>
              <a:endParaRPr lang="zh-CN" alt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" name="直接连接符 16"/>
            <p:cNvCxnSpPr>
              <a:stCxn id="4" idx="2"/>
              <a:endCxn id="7" idx="0"/>
            </p:cNvCxnSpPr>
            <p:nvPr/>
          </p:nvCxnSpPr>
          <p:spPr>
            <a:xfrm>
              <a:off x="4053703" y="1196752"/>
              <a:ext cx="0" cy="196385"/>
            </a:xfrm>
            <a:prstGeom prst="line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接连接符 18"/>
            <p:cNvCxnSpPr>
              <a:stCxn id="7" idx="2"/>
              <a:endCxn id="5" idx="0"/>
            </p:cNvCxnSpPr>
            <p:nvPr/>
          </p:nvCxnSpPr>
          <p:spPr>
            <a:xfrm>
              <a:off x="4053703" y="1681169"/>
              <a:ext cx="1" cy="196385"/>
            </a:xfrm>
            <a:prstGeom prst="line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连接符 20"/>
            <p:cNvCxnSpPr>
              <a:stCxn id="5" idx="2"/>
              <a:endCxn id="9" idx="0"/>
            </p:cNvCxnSpPr>
            <p:nvPr/>
          </p:nvCxnSpPr>
          <p:spPr>
            <a:xfrm>
              <a:off x="4053704" y="2165586"/>
              <a:ext cx="0" cy="196385"/>
            </a:xfrm>
            <a:prstGeom prst="line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接连接符 22"/>
            <p:cNvCxnSpPr>
              <a:stCxn id="9" idx="2"/>
              <a:endCxn id="6" idx="0"/>
            </p:cNvCxnSpPr>
            <p:nvPr/>
          </p:nvCxnSpPr>
          <p:spPr>
            <a:xfrm>
              <a:off x="4053704" y="2650003"/>
              <a:ext cx="0" cy="196385"/>
            </a:xfrm>
            <a:prstGeom prst="line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连接符 24"/>
            <p:cNvCxnSpPr>
              <a:stCxn id="6" idx="2"/>
              <a:endCxn id="10" idx="0"/>
            </p:cNvCxnSpPr>
            <p:nvPr/>
          </p:nvCxnSpPr>
          <p:spPr>
            <a:xfrm flipH="1">
              <a:off x="4053703" y="3134420"/>
              <a:ext cx="1" cy="196385"/>
            </a:xfrm>
            <a:prstGeom prst="line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连接符 26"/>
            <p:cNvCxnSpPr>
              <a:stCxn id="10" idx="2"/>
              <a:endCxn id="8" idx="0"/>
            </p:cNvCxnSpPr>
            <p:nvPr/>
          </p:nvCxnSpPr>
          <p:spPr>
            <a:xfrm>
              <a:off x="4053703" y="3618837"/>
              <a:ext cx="0" cy="196385"/>
            </a:xfrm>
            <a:prstGeom prst="line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接连接符 28"/>
            <p:cNvCxnSpPr>
              <a:stCxn id="8" idx="2"/>
              <a:endCxn id="11" idx="0"/>
            </p:cNvCxnSpPr>
            <p:nvPr/>
          </p:nvCxnSpPr>
          <p:spPr>
            <a:xfrm>
              <a:off x="4053703" y="4103254"/>
              <a:ext cx="1" cy="196385"/>
            </a:xfrm>
            <a:prstGeom prst="line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连接符 30"/>
            <p:cNvCxnSpPr>
              <a:stCxn id="11" idx="2"/>
              <a:endCxn id="12" idx="0"/>
            </p:cNvCxnSpPr>
            <p:nvPr/>
          </p:nvCxnSpPr>
          <p:spPr>
            <a:xfrm>
              <a:off x="4053704" y="4587671"/>
              <a:ext cx="0" cy="196385"/>
            </a:xfrm>
            <a:prstGeom prst="line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2"/>
            <p:cNvCxnSpPr>
              <a:stCxn id="12" idx="2"/>
              <a:endCxn id="13" idx="0"/>
            </p:cNvCxnSpPr>
            <p:nvPr/>
          </p:nvCxnSpPr>
          <p:spPr>
            <a:xfrm>
              <a:off x="4053704" y="5072088"/>
              <a:ext cx="0" cy="196385"/>
            </a:xfrm>
            <a:prstGeom prst="line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连接符 34"/>
            <p:cNvCxnSpPr>
              <a:stCxn id="13" idx="2"/>
              <a:endCxn id="14" idx="0"/>
            </p:cNvCxnSpPr>
            <p:nvPr/>
          </p:nvCxnSpPr>
          <p:spPr>
            <a:xfrm flipH="1">
              <a:off x="4053703" y="5556505"/>
              <a:ext cx="1" cy="196385"/>
            </a:xfrm>
            <a:prstGeom prst="line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接连接符 36"/>
            <p:cNvCxnSpPr>
              <a:stCxn id="14" idx="2"/>
              <a:endCxn id="15" idx="0"/>
            </p:cNvCxnSpPr>
            <p:nvPr/>
          </p:nvCxnSpPr>
          <p:spPr>
            <a:xfrm>
              <a:off x="4053703" y="6040922"/>
              <a:ext cx="0" cy="196390"/>
            </a:xfrm>
            <a:prstGeom prst="line">
              <a:avLst/>
            </a:prstGeom>
            <a:grpFill/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Rectangle 1"/>
          <p:cNvSpPr/>
          <p:nvPr/>
        </p:nvSpPr>
        <p:spPr>
          <a:xfrm>
            <a:off x="470497" y="6372036"/>
            <a:ext cx="67229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lustration for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filtering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cess of WES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8611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</TotalTime>
  <Words>55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SUS</dc:creator>
  <cp:lastModifiedBy>lenovo</cp:lastModifiedBy>
  <cp:revision>11</cp:revision>
  <dcterms:created xsi:type="dcterms:W3CDTF">2020-02-17T11:19:52Z</dcterms:created>
  <dcterms:modified xsi:type="dcterms:W3CDTF">2020-03-21T10:38:23Z</dcterms:modified>
</cp:coreProperties>
</file>